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23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15" userDrawn="1">
          <p15:clr>
            <a:srgbClr val="A4A3A4"/>
          </p15:clr>
        </p15:guide>
        <p15:guide id="5" orient="horz" pos="3120" userDrawn="1">
          <p15:clr>
            <a:srgbClr val="A4A3A4"/>
          </p15:clr>
        </p15:guide>
        <p15:guide id="7" pos="2160" userDrawn="1">
          <p15:clr>
            <a:srgbClr val="A4A3A4"/>
          </p15:clr>
        </p15:guide>
        <p15:guide id="8" orient="horz" pos="8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249FF"/>
    <a:srgbClr val="FFFE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305"/>
    <p:restoredTop sz="94444"/>
  </p:normalViewPr>
  <p:slideViewPr>
    <p:cSldViewPr snapToGrid="0" snapToObjects="1">
      <p:cViewPr varScale="1">
        <p:scale>
          <a:sx n="73" d="100"/>
          <a:sy n="73" d="100"/>
        </p:scale>
        <p:origin x="544" y="200"/>
      </p:cViewPr>
      <p:guideLst>
        <p:guide orient="horz" pos="5615"/>
        <p:guide orient="horz" pos="3120"/>
        <p:guide pos="2160"/>
        <p:guide orient="horz" pos="8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BC56DB-7ED9-E547-B56C-B88B6FEC3E07}" type="datetimeFigureOut">
              <a:rPr lang="en-US" smtClean="0"/>
              <a:t>3/1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F4B0B5-EE68-F745-8FD0-E985A50751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544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4341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8">
            <a:extLst>
              <a:ext uri="{FF2B5EF4-FFF2-40B4-BE49-F238E27FC236}">
                <a16:creationId xmlns:a16="http://schemas.microsoft.com/office/drawing/2014/main" id="{9B4E6A56-1914-BB44-92D2-772C6DE047E1}"/>
              </a:ext>
            </a:extLst>
          </p:cNvPr>
          <p:cNvSpPr txBox="1"/>
          <p:nvPr/>
        </p:nvSpPr>
        <p:spPr>
          <a:xfrm>
            <a:off x="3932880" y="423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Supplementary Figure 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693FF62-1F42-9C45-AD36-FB33DB6BC54A}"/>
              </a:ext>
            </a:extLst>
          </p:cNvPr>
          <p:cNvSpPr txBox="1"/>
          <p:nvPr/>
        </p:nvSpPr>
        <p:spPr>
          <a:xfrm>
            <a:off x="491765" y="652601"/>
            <a:ext cx="328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8AEB2E5-DDE2-3844-A780-4EA411A694E2}"/>
              </a:ext>
            </a:extLst>
          </p:cNvPr>
          <p:cNvSpPr txBox="1"/>
          <p:nvPr/>
        </p:nvSpPr>
        <p:spPr>
          <a:xfrm>
            <a:off x="4768307" y="652601"/>
            <a:ext cx="328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  <p:sp>
        <p:nvSpPr>
          <p:cNvPr id="8" name="テキスト ボックス 8">
            <a:extLst>
              <a:ext uri="{FF2B5EF4-FFF2-40B4-BE49-F238E27FC236}">
                <a16:creationId xmlns:a16="http://schemas.microsoft.com/office/drawing/2014/main" id="{8C9CC3DA-C6E8-0A43-AED9-33ECD5C7C96E}"/>
              </a:ext>
            </a:extLst>
          </p:cNvPr>
          <p:cNvSpPr txBox="1"/>
          <p:nvPr/>
        </p:nvSpPr>
        <p:spPr>
          <a:xfrm>
            <a:off x="526857" y="4010546"/>
            <a:ext cx="5822831" cy="2284746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4 The influence of </a:t>
            </a:r>
            <a:r>
              <a:rPr lang="en-US" sz="1400" b="1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PIKFYVE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knockdown on PI(3)P production in HeLa cells</a:t>
            </a:r>
          </a:p>
          <a:p>
            <a:pPr algn="just"/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HeLa cells stably expressing GFP-2×FYVE were transfected with control, PIKFIYVE#1, or PIKFIVE#2 siRNA for 48 hrs.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Representative confocal live-cell imaging of HeLa cells stably expressing GFP-2×FYVE are shown. Nuclei (blue) were stained with Hoechst33342.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Scale bar: 10 </a:t>
            </a:r>
            <a:r>
              <a:rPr lang="en-US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μm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Means ± S.E.M. of relative signal intensity of GFP-2×FYVE normalized against cells exposed to control siRNA from three independent experiments (</a:t>
            </a:r>
            <a:r>
              <a:rPr lang="en-US" sz="14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N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= 3) including at least 21 cells are shown. * indicates P &lt;0.05 by the two-tailed unpaired </a:t>
            </a:r>
            <a:r>
              <a:rPr lang="en-US" sz="14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t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-test. </a:t>
            </a:r>
            <a:endParaRPr lang="ja-JP" sz="1400" kern="10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A104BB6-6B60-984A-88A7-C8A1815B90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50686" y="1181715"/>
            <a:ext cx="1489364" cy="229754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4853D0F-123C-D844-9F36-6C24FF7016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7605" y="1085887"/>
            <a:ext cx="4064000" cy="248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7998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507</TotalTime>
  <Words>135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ＭＳ 明朝</vt:lpstr>
      <vt:lpstr>ＭＳ 明朝</vt:lpstr>
      <vt:lpstr>游明朝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田中 良法</dc:creator>
  <cp:lastModifiedBy>田中 良法</cp:lastModifiedBy>
  <cp:revision>1550</cp:revision>
  <cp:lastPrinted>2022-02-10T10:10:52Z</cp:lastPrinted>
  <dcterms:created xsi:type="dcterms:W3CDTF">2020-08-12T02:53:40Z</dcterms:created>
  <dcterms:modified xsi:type="dcterms:W3CDTF">2024-03-11T14:27:20Z</dcterms:modified>
</cp:coreProperties>
</file>